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9144000" cy="6858000" type="screen4x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9" d="100"/>
          <a:sy n="109" d="100"/>
        </p:scale>
        <p:origin x="-72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472948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890441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471691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862641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800540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19278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477872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2190246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045465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116559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022923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693514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371600" y="76200"/>
            <a:ext cx="6629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/>
                <a:ea typeface="Times New Roman"/>
              </a:rPr>
              <a:t>Additional file 9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. </a:t>
            </a:r>
            <a:r>
              <a:rPr lang="en-US" sz="1200" dirty="0" err="1" smtClean="0">
                <a:effectLst/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MapMan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 classification of differentially expressed transcripts between four successive </a:t>
            </a:r>
            <a:r>
              <a:rPr lang="en-US" sz="12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sub-apical </a:t>
            </a:r>
            <a:r>
              <a:rPr lang="en-US" sz="12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internodes (</a:t>
            </a:r>
            <a:r>
              <a:rPr lang="en-US" sz="12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Int1-Int4) 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o</a:t>
            </a:r>
            <a:r>
              <a:rPr lang="en-US" sz="12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f </a:t>
            </a:r>
            <a:r>
              <a:rPr lang="en-US" sz="12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bioenergy sorghum </a:t>
            </a:r>
            <a:r>
              <a:rPr lang="en-US" sz="1200" dirty="0" smtClean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inbred R.07020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 grouped in six clusters. </a:t>
            </a:r>
          </a:p>
        </p:txBody>
      </p:sp>
      <p:pic>
        <p:nvPicPr>
          <p:cNvPr id="7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600200" y="496887"/>
            <a:ext cx="5900738" cy="62849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xmlns="" val="16183673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15</TotalTime>
  <Words>28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Kebrom</dc:creator>
  <cp:lastModifiedBy>0012761</cp:lastModifiedBy>
  <cp:revision>83</cp:revision>
  <cp:lastPrinted>2016-04-06T22:28:19Z</cp:lastPrinted>
  <dcterms:created xsi:type="dcterms:W3CDTF">2015-10-14T15:29:02Z</dcterms:created>
  <dcterms:modified xsi:type="dcterms:W3CDTF">2017-06-15T02:45:42Z</dcterms:modified>
</cp:coreProperties>
</file>